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0" d="100"/>
          <a:sy n="140" d="100"/>
        </p:scale>
        <p:origin x="-1944" y="64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47B485-7C74-460D-9C79-70A0A245B95B}" type="datetimeFigureOut">
              <a:rPr lang="en-US" smtClean="0"/>
              <a:pPr/>
              <a:t>10/14/2016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4DDFE7-0FBA-4BEF-9C42-C6F46AC4534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/>
        </p:nvGraphicFramePr>
        <p:xfrm>
          <a:off x="1052736" y="1115616"/>
          <a:ext cx="3816425" cy="4663443"/>
        </p:xfrm>
        <a:graphic>
          <a:graphicData uri="http://schemas.openxmlformats.org/drawingml/2006/table">
            <a:tbl>
              <a:tblPr/>
              <a:tblGrid>
                <a:gridCol w="1168653"/>
                <a:gridCol w="1548124"/>
                <a:gridCol w="1099648"/>
              </a:tblGrid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Name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Primer sequence (5'-3')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Target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CR-sequencing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RSc1097-L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GGCTCGAGCTGGCGGCA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efpR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 locus 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c1097-R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GGGCGCGCATGCAGACG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efpR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 locus 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mutagenesis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AP3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CCTGGACCACGCTCTA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efpR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 locus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AP4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CGCGAGAACACCGGAAA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efpR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 locus 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2378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quantitative RT-PCR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efpR_L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GCAAGCGTGTCAAGCAATG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efpR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efpR_R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ACAGTTCGGAGAGCGTGA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efpR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c0368_F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CATCGCCTTTGTGCTGATC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c0368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c0368_R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CCGGTGCTGTGGATCCAG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c0368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c0403_F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CGCGCGTACATCAAGGAATT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c0403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c0403_R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GCTTTGCAGGAAGTCGATG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c0403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p0272_F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GGCTGTGCTTTATCGTTG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p0272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p0272_R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AAAGTCACTGATGCTGGC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Sp0272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ibodepletion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 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47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AGPCATCLACCACETGCALTT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48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TGECCCAZACGGPCCGPGTTT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49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TCAGECAGGETTTCACPTGTCL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0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TTCAECCTGPCCATPGATAGET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TTCGGEGTTZGCTATGPCGGGPT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2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AGACECCTTLACAPGCTTALAG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3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CLTAACPTCGCTLGCCCCALA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4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GTTTALCGGGALTTCAETCAAP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5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CCEGGGTGGZATTTCAEGGTLGG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6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TATLCCCAPAGTALCTTTTAZC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7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GPAATCLTCATCTZCAGGCGEGT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23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8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CGGZATTAGLTAGTLTTTCPACT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6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59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CCTTETTCTTLCGGZACCGTLAT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6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</a:rPr>
                        <a:t>16S-740</a:t>
                      </a:r>
                      <a:r>
                        <a:rPr lang="en-US" sz="800" b="0" i="0" u="none" strike="noStrike" baseline="30000" dirty="0" smtClean="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lang="en-US" sz="800" b="0" i="0" u="none" strike="noStrike" baseline="30000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CCAPGGTATLTAATCLTGTTZG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6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</a:rPr>
                        <a:t>16S-1041</a:t>
                      </a:r>
                      <a:r>
                        <a:rPr lang="en-US" sz="800" b="0" i="0" u="none" strike="noStrike" baseline="30000" dirty="0" smtClean="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lang="en-US" sz="800" b="0" i="0" u="none" strike="noStrike" baseline="30000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GGGALTTAALCCAALATCTCECG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6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</a:rPr>
                        <a:t>16S-1333</a:t>
                      </a:r>
                      <a:r>
                        <a:rPr lang="en-US" sz="800" b="0" i="0" u="none" strike="noStrike" baseline="30000" dirty="0" smtClean="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GGZGTGACPGGCGGZGTGTECA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6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60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TGAEACGALTCCGCPCCGATPAT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61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ACCETAGCPAGTCGPTACCALCC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S rRNA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62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TCAPGTGGTZAGAGCECCGTLTT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RNA-Ala(TGC)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237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oNP763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Courier New"/>
                        </a:rPr>
                        <a:t>TCAPCTGGGEGAGCALCTGCZTT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tRNA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-Ile(GAT)</a:t>
                      </a:r>
                    </a:p>
                  </a:txBody>
                  <a:tcPr marL="4119" marR="4119" marT="41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949664" y="5844044"/>
            <a:ext cx="3919496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Note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. All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oligos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ribodepletion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section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are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modified in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5’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Biotine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-TEG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Eurogentec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. Bases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E, L, P and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Z correspond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to A, C, G and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T,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LNA bases respectively.</a:t>
            </a:r>
          </a:p>
          <a:p>
            <a:pPr algn="just"/>
            <a:endParaRPr lang="en-US" sz="11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baseline="30000" dirty="0" smtClean="0">
                <a:latin typeface="Times New Roman" pitchFamily="18" charset="0"/>
                <a:cs typeface="Times New Roman" pitchFamily="18" charset="0"/>
              </a:rPr>
              <a:t>a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Sallet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E, Roux B,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Sauviac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L,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Jardinaud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M-F,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Carrere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S,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Faraut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T, de Carvalho-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Niebel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F,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Gouzy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J,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Gamas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P, Capela D,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Bruand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C,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Schiex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T. 2013.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Next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Generation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Annotation of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Prokaryotic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Genomes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EuGene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-P: Application to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Sinorhizobium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meliloti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2011. DNA </a:t>
            </a:r>
            <a:r>
              <a:rPr lang="fr-FR" sz="800" dirty="0" err="1" smtClean="0">
                <a:latin typeface="Times New Roman" pitchFamily="18" charset="0"/>
                <a:cs typeface="Times New Roman" pitchFamily="18" charset="0"/>
              </a:rPr>
              <a:t>Res</a:t>
            </a:r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 20:339–354. 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967080" y="755576"/>
            <a:ext cx="38884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5 Table. Primers used in this study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967080" y="395536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Perrier et al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245</Words>
  <Application>Microsoft Office PowerPoint</Application>
  <PresentationFormat>Affichage à l'écran (4:3)</PresentationFormat>
  <Paragraphs>11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nperrier</dc:creator>
  <cp:lastModifiedBy>aguidot</cp:lastModifiedBy>
  <cp:revision>10</cp:revision>
  <dcterms:created xsi:type="dcterms:W3CDTF">2016-10-14T11:12:00Z</dcterms:created>
  <dcterms:modified xsi:type="dcterms:W3CDTF">2016-10-14T13:32:34Z</dcterms:modified>
</cp:coreProperties>
</file>